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bookmarkIdSeed="3">
  <p:sldMasterIdLst>
    <p:sldMasterId id="2147483672" r:id="rId4"/>
  </p:sldMasterIdLst>
  <p:notesMasterIdLst>
    <p:notesMasterId r:id="rId6"/>
  </p:notesMasterIdLst>
  <p:sldIdLst>
    <p:sldId id="1760" r:id="rId5"/>
  </p:sldIdLst>
  <p:sldSz cx="12192000" cy="6858000"/>
  <p:notesSz cx="6808788" cy="9940925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521415D9-36F7-43E2-AB2F-B90AF26B5E84}">
      <p14:sectionLst xmlns:p14="http://schemas.microsoft.com/office/powerpoint/2010/main">
        <p14:section name="Preface" id="{3EF1F56A-8102-4ADB-99D2-BEA25927122D}">
          <p14:sldIdLst/>
        </p14:section>
        <p14:section name="DRC update" id="{866E2E53-76E7-460A-8851-0C098C2AA320}">
          <p14:sldIdLst/>
        </p14:section>
        <p14:section name="Community deaths" id="{C6FBBB4C-2475-4F58-A038-EBC25885C255}">
          <p14:sldIdLst/>
        </p14:section>
        <p14:section name="Contact status" id="{00BBD4C9-F929-4E69-A327-845863FC4C72}">
          <p14:sldIdLst/>
        </p14:section>
        <p14:section name="Age Gender distribution" id="{4021D178-08D5-424A-A042-52BD96571FE6}">
          <p14:sldIdLst/>
        </p14:section>
        <p14:section name="Exposures and delays" id="{889C24A3-979F-41E1-ADA4-F05F551F0EFF}">
          <p14:sldIdLst/>
        </p14:section>
        <p14:section name="Alerts" id="{FA4F0C62-1C4B-4195-88A9-8305E5EE82F8}">
          <p14:sldIdLst>
            <p14:sldId id="1760"/>
          </p14:sldIdLst>
        </p14:section>
        <p14:section name="Contact tracing" id="{CA6D8037-A31A-4AB1-99C0-5379FEEEA36A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DONGO, Wycliffe Onyango" initials="OWO" lastIdx="1" clrIdx="0"/>
  <p:cmAuthor id="2" name="DEGAIL CHABRAT, Marie Amélie" initials="DCMA" lastIdx="4" clrIdx="1"/>
  <p:cmAuthor id="3" name="BATRA, Neale Spencer" initials="BNS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00"/>
    <a:srgbClr val="FFFFFF"/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09" autoAdjust="0"/>
    <p:restoredTop sz="94291" autoAdjust="0"/>
  </p:normalViewPr>
  <p:slideViewPr>
    <p:cSldViewPr>
      <p:cViewPr varScale="1">
        <p:scale>
          <a:sx n="84" d="100"/>
          <a:sy n="84" d="100"/>
        </p:scale>
        <p:origin x="-998" y="-62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U, Olushayo Oluseun" userId="6ce1f906-93df-4b7f-942f-82f7ff16e264" providerId="ADAL" clId="{B624E325-8DF0-451F-8429-DBBE477EB1CB}"/>
    <pc:docChg chg="delSld modSld modSection">
      <pc:chgData name="OLU, Olushayo Oluseun" userId="6ce1f906-93df-4b7f-942f-82f7ff16e264" providerId="ADAL" clId="{B624E325-8DF0-451F-8429-DBBE477EB1CB}" dt="2020-09-14T10:46:38.359" v="21" actId="6549"/>
      <pc:docMkLst>
        <pc:docMk/>
      </pc:docMkLst>
      <pc:sldChg chg="del">
        <pc:chgData name="OLU, Olushayo Oluseun" userId="6ce1f906-93df-4b7f-942f-82f7ff16e264" providerId="ADAL" clId="{B624E325-8DF0-451F-8429-DBBE477EB1CB}" dt="2020-09-14T10:46:14.701" v="20" actId="2696"/>
        <pc:sldMkLst>
          <pc:docMk/>
          <pc:sldMk cId="1136004356" sldId="482"/>
        </pc:sldMkLst>
      </pc:sldChg>
      <pc:sldChg chg="del">
        <pc:chgData name="OLU, Olushayo Oluseun" userId="6ce1f906-93df-4b7f-942f-82f7ff16e264" providerId="ADAL" clId="{B624E325-8DF0-451F-8429-DBBE477EB1CB}" dt="2020-09-14T10:45:52.044" v="0" actId="2696"/>
        <pc:sldMkLst>
          <pc:docMk/>
          <pc:sldMk cId="3407297240" sldId="822"/>
        </pc:sldMkLst>
      </pc:sldChg>
      <pc:sldChg chg="del">
        <pc:chgData name="OLU, Olushayo Oluseun" userId="6ce1f906-93df-4b7f-942f-82f7ff16e264" providerId="ADAL" clId="{B624E325-8DF0-451F-8429-DBBE477EB1CB}" dt="2020-09-14T10:45:53.373" v="3" actId="2696"/>
        <pc:sldMkLst>
          <pc:docMk/>
          <pc:sldMk cId="3267736934" sldId="1722"/>
        </pc:sldMkLst>
      </pc:sldChg>
      <pc:sldChg chg="modSp">
        <pc:chgData name="OLU, Olushayo Oluseun" userId="6ce1f906-93df-4b7f-942f-82f7ff16e264" providerId="ADAL" clId="{B624E325-8DF0-451F-8429-DBBE477EB1CB}" dt="2020-09-14T10:46:38.359" v="21" actId="6549"/>
        <pc:sldMkLst>
          <pc:docMk/>
          <pc:sldMk cId="2813573780" sldId="1760"/>
        </pc:sldMkLst>
        <pc:spChg chg="mod">
          <ac:chgData name="OLU, Olushayo Oluseun" userId="6ce1f906-93df-4b7f-942f-82f7ff16e264" providerId="ADAL" clId="{B624E325-8DF0-451F-8429-DBBE477EB1CB}" dt="2020-09-14T10:46:38.359" v="21" actId="6549"/>
          <ac:spMkLst>
            <pc:docMk/>
            <pc:sldMk cId="2813573780" sldId="1760"/>
            <ac:spMk id="7" creationId="{9037F4B7-9383-497F-92B1-736E7A3C7C1F}"/>
          </ac:spMkLst>
        </pc:spChg>
      </pc:sldChg>
      <pc:sldChg chg="del">
        <pc:chgData name="OLU, Olushayo Oluseun" userId="6ce1f906-93df-4b7f-942f-82f7ff16e264" providerId="ADAL" clId="{B624E325-8DF0-451F-8429-DBBE477EB1CB}" dt="2020-09-14T10:45:55.906" v="7" actId="2696"/>
        <pc:sldMkLst>
          <pc:docMk/>
          <pc:sldMk cId="864848200" sldId="1761"/>
        </pc:sldMkLst>
      </pc:sldChg>
      <pc:sldChg chg="del">
        <pc:chgData name="OLU, Olushayo Oluseun" userId="6ce1f906-93df-4b7f-942f-82f7ff16e264" providerId="ADAL" clId="{B624E325-8DF0-451F-8429-DBBE477EB1CB}" dt="2020-09-14T10:45:53.037" v="2" actId="2696"/>
        <pc:sldMkLst>
          <pc:docMk/>
          <pc:sldMk cId="1023983645" sldId="1778"/>
        </pc:sldMkLst>
      </pc:sldChg>
      <pc:sldChg chg="del">
        <pc:chgData name="OLU, Olushayo Oluseun" userId="6ce1f906-93df-4b7f-942f-82f7ff16e264" providerId="ADAL" clId="{B624E325-8DF0-451F-8429-DBBE477EB1CB}" dt="2020-09-14T10:45:52.652" v="1" actId="2696"/>
        <pc:sldMkLst>
          <pc:docMk/>
          <pc:sldMk cId="1381085773" sldId="1804"/>
        </pc:sldMkLst>
      </pc:sldChg>
      <pc:sldChg chg="del">
        <pc:chgData name="OLU, Olushayo Oluseun" userId="6ce1f906-93df-4b7f-942f-82f7ff16e264" providerId="ADAL" clId="{B624E325-8DF0-451F-8429-DBBE477EB1CB}" dt="2020-09-14T10:45:53.870" v="4" actId="2696"/>
        <pc:sldMkLst>
          <pc:docMk/>
          <pc:sldMk cId="3158633404" sldId="1806"/>
        </pc:sldMkLst>
      </pc:sldChg>
      <pc:sldChg chg="del">
        <pc:chgData name="OLU, Olushayo Oluseun" userId="6ce1f906-93df-4b7f-942f-82f7ff16e264" providerId="ADAL" clId="{B624E325-8DF0-451F-8429-DBBE477EB1CB}" dt="2020-09-14T10:45:56.560" v="8" actId="2696"/>
        <pc:sldMkLst>
          <pc:docMk/>
          <pc:sldMk cId="525145658" sldId="1819"/>
        </pc:sldMkLst>
      </pc:sldChg>
      <pc:sldChg chg="del">
        <pc:chgData name="OLU, Olushayo Oluseun" userId="6ce1f906-93df-4b7f-942f-82f7ff16e264" providerId="ADAL" clId="{B624E325-8DF0-451F-8429-DBBE477EB1CB}" dt="2020-09-14T10:45:54.019" v="5" actId="2696"/>
        <pc:sldMkLst>
          <pc:docMk/>
          <pc:sldMk cId="1968961547" sldId="1830"/>
        </pc:sldMkLst>
      </pc:sldChg>
      <pc:sldChg chg="del">
        <pc:chgData name="OLU, Olushayo Oluseun" userId="6ce1f906-93df-4b7f-942f-82f7ff16e264" providerId="ADAL" clId="{B624E325-8DF0-451F-8429-DBBE477EB1CB}" dt="2020-09-14T10:45:59.480" v="12" actId="2696"/>
        <pc:sldMkLst>
          <pc:docMk/>
          <pc:sldMk cId="3380751911" sldId="1833"/>
        </pc:sldMkLst>
      </pc:sldChg>
      <pc:sldChg chg="del">
        <pc:chgData name="OLU, Olushayo Oluseun" userId="6ce1f906-93df-4b7f-942f-82f7ff16e264" providerId="ADAL" clId="{B624E325-8DF0-451F-8429-DBBE477EB1CB}" dt="2020-09-14T10:45:54.327" v="6" actId="2696"/>
        <pc:sldMkLst>
          <pc:docMk/>
          <pc:sldMk cId="4121305445" sldId="1837"/>
        </pc:sldMkLst>
      </pc:sldChg>
      <pc:sldChg chg="del">
        <pc:chgData name="OLU, Olushayo Oluseun" userId="6ce1f906-93df-4b7f-942f-82f7ff16e264" providerId="ADAL" clId="{B624E325-8DF0-451F-8429-DBBE477EB1CB}" dt="2020-09-14T10:45:57.265" v="9" actId="2696"/>
        <pc:sldMkLst>
          <pc:docMk/>
          <pc:sldMk cId="2505774632" sldId="1839"/>
        </pc:sldMkLst>
      </pc:sldChg>
      <pc:sldChg chg="del">
        <pc:chgData name="OLU, Olushayo Oluseun" userId="6ce1f906-93df-4b7f-942f-82f7ff16e264" providerId="ADAL" clId="{B624E325-8DF0-451F-8429-DBBE477EB1CB}" dt="2020-09-14T10:45:57.996" v="10" actId="2696"/>
        <pc:sldMkLst>
          <pc:docMk/>
          <pc:sldMk cId="3377934371" sldId="1840"/>
        </pc:sldMkLst>
      </pc:sldChg>
      <pc:sldChg chg="del">
        <pc:chgData name="OLU, Olushayo Oluseun" userId="6ce1f906-93df-4b7f-942f-82f7ff16e264" providerId="ADAL" clId="{B624E325-8DF0-451F-8429-DBBE477EB1CB}" dt="2020-09-14T10:45:58.734" v="11" actId="2696"/>
        <pc:sldMkLst>
          <pc:docMk/>
          <pc:sldMk cId="1973537614" sldId="1841"/>
        </pc:sldMkLst>
      </pc:sldChg>
      <pc:sldChg chg="del">
        <pc:chgData name="OLU, Olushayo Oluseun" userId="6ce1f906-93df-4b7f-942f-82f7ff16e264" providerId="ADAL" clId="{B624E325-8DF0-451F-8429-DBBE477EB1CB}" dt="2020-09-14T10:46:00.171" v="14" actId="2696"/>
        <pc:sldMkLst>
          <pc:docMk/>
          <pc:sldMk cId="2700092733" sldId="1842"/>
        </pc:sldMkLst>
      </pc:sldChg>
      <pc:sldChg chg="del">
        <pc:chgData name="OLU, Olushayo Oluseun" userId="6ce1f906-93df-4b7f-942f-82f7ff16e264" providerId="ADAL" clId="{B624E325-8DF0-451F-8429-DBBE477EB1CB}" dt="2020-09-14T10:45:59.861" v="13" actId="2696"/>
        <pc:sldMkLst>
          <pc:docMk/>
          <pc:sldMk cId="3605043114" sldId="1843"/>
        </pc:sldMkLst>
      </pc:sldChg>
      <pc:sldChg chg="del">
        <pc:chgData name="OLU, Olushayo Oluseun" userId="6ce1f906-93df-4b7f-942f-82f7ff16e264" providerId="ADAL" clId="{B624E325-8DF0-451F-8429-DBBE477EB1CB}" dt="2020-09-14T10:46:12.101" v="19" actId="2696"/>
        <pc:sldMkLst>
          <pc:docMk/>
          <pc:sldMk cId="264986751" sldId="1846"/>
        </pc:sldMkLst>
      </pc:sldChg>
      <pc:sldChg chg="del">
        <pc:chgData name="OLU, Olushayo Oluseun" userId="6ce1f906-93df-4b7f-942f-82f7ff16e264" providerId="ADAL" clId="{B624E325-8DF0-451F-8429-DBBE477EB1CB}" dt="2020-09-14T10:46:00.866" v="15" actId="2696"/>
        <pc:sldMkLst>
          <pc:docMk/>
          <pc:sldMk cId="3974040177" sldId="1847"/>
        </pc:sldMkLst>
      </pc:sldChg>
      <pc:sldChg chg="del">
        <pc:chgData name="OLU, Olushayo Oluseun" userId="6ce1f906-93df-4b7f-942f-82f7ff16e264" providerId="ADAL" clId="{B624E325-8DF0-451F-8429-DBBE477EB1CB}" dt="2020-09-14T10:46:01.703" v="16" actId="2696"/>
        <pc:sldMkLst>
          <pc:docMk/>
          <pc:sldMk cId="2793795848" sldId="1848"/>
        </pc:sldMkLst>
      </pc:sldChg>
      <pc:sldChg chg="del">
        <pc:chgData name="OLU, Olushayo Oluseun" userId="6ce1f906-93df-4b7f-942f-82f7ff16e264" providerId="ADAL" clId="{B624E325-8DF0-451F-8429-DBBE477EB1CB}" dt="2020-09-14T10:46:03.532" v="17" actId="2696"/>
        <pc:sldMkLst>
          <pc:docMk/>
          <pc:sldMk cId="317445960" sldId="1849"/>
        </pc:sldMkLst>
      </pc:sldChg>
      <pc:sldChg chg="del">
        <pc:chgData name="OLU, Olushayo Oluseun" userId="6ce1f906-93df-4b7f-942f-82f7ff16e264" providerId="ADAL" clId="{B624E325-8DF0-451F-8429-DBBE477EB1CB}" dt="2020-09-14T10:46:05.956" v="18" actId="2696"/>
        <pc:sldMkLst>
          <pc:docMk/>
          <pc:sldMk cId="146415554" sldId="185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475" cy="497046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en-US" altLang="en-US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6737" y="0"/>
            <a:ext cx="2950475" cy="497046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DBF75A40-944A-4C72-ACAE-20A8E6C00D66}" type="datetimeFigureOut">
              <a:rPr lang="fr-FR" altLang="en-US"/>
              <a:pPr/>
              <a:t>06/11/2020</a:t>
            </a:fld>
            <a:endParaRPr lang="fr-FR" altLang="en-US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2075" y="746125"/>
            <a:ext cx="6624638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fr-FR" noProof="0" dirty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0879" y="4721940"/>
            <a:ext cx="5447030" cy="4473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noProof="0"/>
              <a:t>Cliquez pour modifier les styles du texte du masque</a:t>
            </a:r>
          </a:p>
          <a:p>
            <a:pPr lvl="1"/>
            <a:r>
              <a:rPr lang="fr-FR" noProof="0"/>
              <a:t>Deuxième niveau</a:t>
            </a:r>
          </a:p>
          <a:p>
            <a:pPr lvl="2"/>
            <a:r>
              <a:rPr lang="fr-FR" noProof="0"/>
              <a:t>Troisième niveau</a:t>
            </a:r>
          </a:p>
          <a:p>
            <a:pPr lvl="3"/>
            <a:r>
              <a:rPr lang="fr-FR" noProof="0"/>
              <a:t>Quatrième niveau</a:t>
            </a:r>
          </a:p>
          <a:p>
            <a:pPr lvl="4"/>
            <a:r>
              <a:rPr lang="fr-FR" noProof="0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2154"/>
            <a:ext cx="2950475" cy="49704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en-US" altLang="en-US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6737" y="9442154"/>
            <a:ext cx="2950475" cy="49704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5F84E6A9-2290-4A38-9FBA-6DCB53A8D1A5}" type="slidenum">
              <a:rPr lang="fr-FR" altLang="da-DK"/>
              <a:pPr/>
              <a:t>‹#›</a:t>
            </a:fld>
            <a:endParaRPr lang="fr-FR" altLang="da-DK" dirty="0"/>
          </a:p>
        </p:txBody>
      </p:sp>
    </p:spTree>
    <p:extLst>
      <p:ext uri="{BB962C8B-B14F-4D97-AF65-F5344CB8AC3E}">
        <p14:creationId xmlns:p14="http://schemas.microsoft.com/office/powerpoint/2010/main" val="101245540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 typeface="Arial" panose="020B0604020202020204" pitchFamily="34" charset="0"/>
              <a:buNone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5F84E6A9-2290-4A38-9FBA-6DCB53A8D1A5}" type="slidenum">
              <a:rPr kumimoji="0" lang="fr-FR" altLang="da-DK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itchFamily="34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fr-FR" altLang="da-DK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itchFamily="34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3644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 userDrawn="1"/>
        </p:nvSpPr>
        <p:spPr>
          <a:xfrm>
            <a:off x="0" y="-99392"/>
            <a:ext cx="12192000" cy="13681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</a:pPr>
            <a:endParaRPr lang="en-GB" dirty="0">
              <a:solidFill>
                <a:prstClr val="white">
                  <a:lumMod val="75000"/>
                </a:prstClr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28800" y="1844825"/>
            <a:ext cx="10363200" cy="1470025"/>
          </a:xfrm>
        </p:spPr>
        <p:txBody>
          <a:bodyPr/>
          <a:lstStyle>
            <a:lvl1pPr algn="l">
              <a:defRPr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2962189"/>
            <a:ext cx="8534400" cy="792088"/>
          </a:xfrm>
        </p:spPr>
        <p:txBody>
          <a:bodyPr>
            <a:normAutofit/>
          </a:bodyPr>
          <a:lstStyle>
            <a:lvl1pPr marL="0" indent="0" algn="l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Rectangle 9"/>
          <p:cNvSpPr/>
          <p:nvPr userDrawn="1"/>
        </p:nvSpPr>
        <p:spPr>
          <a:xfrm>
            <a:off x="0" y="5489848"/>
            <a:ext cx="12192000" cy="13681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</a:pPr>
            <a:endParaRPr lang="en-GB" dirty="0">
              <a:solidFill>
                <a:prstClr val="white">
                  <a:lumMod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7859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74063736-2571-49AC-91D1-36E59EA8FC81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67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891" y="116632"/>
            <a:ext cx="10972800" cy="1143000"/>
          </a:xfrm>
        </p:spPr>
        <p:txBody>
          <a:bodyPr>
            <a:normAutofit/>
          </a:bodyPr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400" b="0"/>
            </a:lvl1pPr>
            <a:lvl2pPr>
              <a:defRPr sz="2000" b="0"/>
            </a:lvl2pPr>
            <a:lvl3pPr>
              <a:defRPr sz="1800" b="0"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880309" y="44624"/>
            <a:ext cx="2844800" cy="365125"/>
          </a:xfrm>
          <a:prstGeom prst="rect">
            <a:avLst/>
          </a:prstGeom>
        </p:spPr>
        <p:txBody>
          <a:bodyPr/>
          <a:lstStyle/>
          <a:p>
            <a:fld id="{FDF3167B-FAB2-4064-BC20-4CA053C862DA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9409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>
                <a:solidFill>
                  <a:srgbClr val="0070C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20828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3E5938DE-CE11-43F2-A1EE-D4C7DEBEA006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95460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0070C0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0070C0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2A15CA5A-B3F3-457B-AA8F-DC09651D03AC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4014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941BC9E8-5C3C-4750-A92E-8BCDB9B31434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9828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3744C38A-CC3A-43E1-BF47-CC4E68F6ED37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3628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3050"/>
            <a:ext cx="10959008" cy="779686"/>
          </a:xfrm>
        </p:spPr>
        <p:txBody>
          <a:bodyPr anchor="b"/>
          <a:lstStyle>
            <a:lvl1pPr algn="l">
              <a:defRPr sz="2000" b="1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1268760"/>
            <a:ext cx="6815667" cy="485740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268760"/>
            <a:ext cx="4011084" cy="485740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916047E8-DF3C-428A-AAE6-FDED3553341D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1191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>
                <a:solidFill>
                  <a:srgbClr val="0070C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58194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/>
          <a:lstStyle/>
          <a:p>
            <a:fld id="{20B5C5CC-369C-430B-83F5-EF5E2936E47B}" type="datetime4">
              <a:rPr lang="en-GB" smtClean="0">
                <a:solidFill>
                  <a:prstClr val="white"/>
                </a:solidFill>
              </a:rPr>
              <a:pPr/>
              <a:t>06 November 2020</a:t>
            </a:fld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266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19819" y="602128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fld id="{72E375D5-DD51-4DDF-87E6-FA82A457ECD1}" type="slidenum">
              <a:rPr lang="en-GB" smtClean="0">
                <a:solidFill>
                  <a:prstClr val="black">
                    <a:tint val="75000"/>
                  </a:prstClr>
                </a:solidFill>
                <a:latin typeface="Calibri"/>
                <a:cs typeface="+mn-cs"/>
              </a:rPr>
              <a:pPr eaLnBrk="1" fontAlgn="auto" hangingPunct="1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  <a:latin typeface="Calibri"/>
              <a:cs typeface="+mn-cs"/>
            </a:endParaRPr>
          </a:p>
        </p:txBody>
      </p:sp>
      <p:sp>
        <p:nvSpPr>
          <p:cNvPr id="7" name="Rectangle 6"/>
          <p:cNvSpPr/>
          <p:nvPr userDrawn="1"/>
        </p:nvSpPr>
        <p:spPr>
          <a:xfrm>
            <a:off x="0" y="-27384"/>
            <a:ext cx="12192000" cy="1196817"/>
          </a:xfrm>
          <a:prstGeom prst="rect">
            <a:avLst/>
          </a:prstGeom>
          <a:solidFill>
            <a:srgbClr val="1E7FB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</a:pPr>
            <a:endParaRPr lang="en-GB" dirty="0">
              <a:solidFill>
                <a:prstClr val="white"/>
              </a:solidFill>
            </a:endParaRP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cxnSp>
        <p:nvCxnSpPr>
          <p:cNvPr id="16" name="Straight Connector 15"/>
          <p:cNvCxnSpPr/>
          <p:nvPr userDrawn="1"/>
        </p:nvCxnSpPr>
        <p:spPr>
          <a:xfrm>
            <a:off x="-12288" y="6021288"/>
            <a:ext cx="12204288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Date Placeholder 17"/>
          <p:cNvSpPr>
            <a:spLocks noGrp="1"/>
          </p:cNvSpPr>
          <p:nvPr>
            <p:ph type="dt" sz="half" idx="2"/>
          </p:nvPr>
        </p:nvSpPr>
        <p:spPr>
          <a:xfrm>
            <a:off x="8880000" y="3600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1"/>
                </a:solidFill>
                <a:latin typeface="Segoe Condensed" panose="020B0606040200020203" pitchFamily="34" charset="0"/>
              </a:defRPr>
            </a:lvl1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fld id="{D0E4CC02-274F-49DB-A9AF-7C2A340E6BF4}" type="datetime4">
              <a:rPr lang="en-GB" smtClean="0">
                <a:solidFill>
                  <a:prstClr val="white"/>
                </a:solidFill>
                <a:cs typeface="+mn-cs"/>
              </a:rPr>
              <a:pPr eaLnBrk="1" fontAlgn="auto" hangingPunct="1">
                <a:spcBef>
                  <a:spcPts val="0"/>
                </a:spcBef>
                <a:spcAft>
                  <a:spcPts val="0"/>
                </a:spcAft>
              </a:pPr>
              <a:t>06 November 2020</a:t>
            </a:fld>
            <a:endParaRPr lang="en-GB" dirty="0">
              <a:solidFill>
                <a:prstClr val="white"/>
              </a:solidFill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01518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</p:sldLayoutIdLst>
  <p:timing>
    <p:tnLst>
      <p:par>
        <p:cTn id="1" dur="indefinite" restart="never" nodeType="tmRoot"/>
      </p:par>
    </p:tnLst>
  </p:timing>
  <p:hf sldNum="0" hdr="0" ftr="0"/>
  <p:txStyles>
    <p:titleStyle>
      <a:lvl1pPr algn="l" defTabSz="914400" rtl="0" eaLnBrk="1" latinLnBrk="0" hangingPunct="1">
        <a:spcBef>
          <a:spcPct val="0"/>
        </a:spcBef>
        <a:buNone/>
        <a:defRPr sz="4400" b="1" kern="1200">
          <a:solidFill>
            <a:schemeClr val="bg1"/>
          </a:solidFill>
          <a:latin typeface="Segoe Condensed" panose="020B0606040200020203" pitchFamily="34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b="1" kern="1200">
          <a:solidFill>
            <a:schemeClr val="tx1">
              <a:lumMod val="50000"/>
              <a:lumOff val="50000"/>
            </a:schemeClr>
          </a:solidFill>
          <a:latin typeface="Segoe Condensed" panose="020B0606040200020203" pitchFamily="34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b="1" kern="1200">
          <a:solidFill>
            <a:schemeClr val="tx1">
              <a:lumMod val="50000"/>
              <a:lumOff val="50000"/>
            </a:schemeClr>
          </a:solidFill>
          <a:latin typeface="Segoe Condensed" panose="020B0606040200020203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b="1" kern="1200">
          <a:solidFill>
            <a:schemeClr val="tx1">
              <a:lumMod val="50000"/>
              <a:lumOff val="50000"/>
            </a:schemeClr>
          </a:solidFill>
          <a:latin typeface="Segoe Condensed" panose="020B0606040200020203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b="1" kern="1200">
          <a:solidFill>
            <a:schemeClr val="tx1">
              <a:lumMod val="50000"/>
              <a:lumOff val="50000"/>
            </a:schemeClr>
          </a:solidFill>
          <a:latin typeface="Segoe Condensed" panose="020B0606040200020203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b="1" kern="1200">
          <a:solidFill>
            <a:schemeClr val="tx1">
              <a:lumMod val="50000"/>
              <a:lumOff val="50000"/>
            </a:schemeClr>
          </a:solidFill>
          <a:latin typeface="Segoe Condensed" panose="020B0606040200020203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9">
            <a:extLst>
              <a:ext uri="{FF2B5EF4-FFF2-40B4-BE49-F238E27FC236}">
                <a16:creationId xmlns:a16="http://schemas.microsoft.com/office/drawing/2014/main" xmlns="" id="{6EA7F3F5-913F-4D90-979A-2A4B86EAA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368" y="0"/>
            <a:ext cx="9879632" cy="1143000"/>
          </a:xfrm>
        </p:spPr>
        <p:txBody>
          <a:bodyPr>
            <a:normAutofit/>
          </a:bodyPr>
          <a:lstStyle/>
          <a:p>
            <a:r>
              <a:rPr lang="en-GB" dirty="0"/>
              <a:t>Alerts from other provinces and neighbouring countries</a:t>
            </a:r>
            <a:br>
              <a:rPr lang="en-GB" dirty="0"/>
            </a:br>
            <a:r>
              <a:rPr lang="en-GB" sz="2400" dirty="0"/>
              <a:t>(data from 1 Aug 2018 – 25 Nov 2019)</a:t>
            </a:r>
            <a:endParaRPr lang="en-GB" sz="3200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xmlns="" id="{9037F4B7-9383-497F-92B1-736E7A3C7C1F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966200" y="0"/>
            <a:ext cx="2844800" cy="365125"/>
          </a:xfrm>
        </p:spPr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Segoe Condensed" panose="020B0606040200020203" pitchFamily="34" charset="0"/>
              <a:ea typeface="+mn-ea"/>
              <a:cs typeface="Arial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0DF5F921-41DC-42B5-BF76-708CFC62F15D}"/>
              </a:ext>
            </a:extLst>
          </p:cNvPr>
          <p:cNvSpPr txBox="1"/>
          <p:nvPr/>
        </p:nvSpPr>
        <p:spPr>
          <a:xfrm>
            <a:off x="4572000" y="1813173"/>
            <a:ext cx="7467600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2400" dirty="0">
                <a:solidFill>
                  <a:prstClr val="black"/>
                </a:solidFill>
                <a:latin typeface="Segoe Condensed" panose="020B0606040200020203" pitchFamily="34" charset="0"/>
              </a:rPr>
              <a:t>Very high risk remain at national and regional level, and low at global level</a:t>
            </a:r>
          </a:p>
          <a:p>
            <a:pPr marL="285750" lvl="0" indent="-285750">
              <a:buFont typeface="Arial" panose="020B0604020202020204" pitchFamily="34" charset="0"/>
              <a:buChar char="•"/>
              <a:defRPr/>
            </a:pPr>
            <a:endParaRPr lang="en-US" sz="2400" dirty="0">
              <a:solidFill>
                <a:prstClr val="black"/>
              </a:solidFill>
              <a:latin typeface="Segoe Condensed" panose="020B0606040200020203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2400" dirty="0">
                <a:solidFill>
                  <a:prstClr val="black"/>
                </a:solidFill>
                <a:latin typeface="Segoe Condensed" panose="020B0606040200020203" pitchFamily="34" charset="0"/>
              </a:rPr>
              <a:t>Enhanced surveillance and preparedness ongoing in 9 priority countries and elsewhere</a:t>
            </a:r>
          </a:p>
          <a:p>
            <a:pPr marL="285750" lvl="0" indent="-285750">
              <a:buFont typeface="Arial" panose="020B0604020202020204" pitchFamily="34" charset="0"/>
              <a:buChar char="•"/>
              <a:defRPr/>
            </a:pPr>
            <a:endParaRPr lang="en-US" sz="2400" dirty="0">
              <a:solidFill>
                <a:prstClr val="black"/>
              </a:solidFill>
              <a:latin typeface="Segoe Condensed" panose="020B0606040200020203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2400" dirty="0">
                <a:solidFill>
                  <a:prstClr val="black"/>
                </a:solidFill>
                <a:latin typeface="Segoe Condensed" panose="020B0606040200020203" pitchFamily="34" charset="0"/>
              </a:rPr>
              <a:t>To date, </a:t>
            </a:r>
            <a:r>
              <a:rPr lang="en-US" sz="2400" b="1" dirty="0">
                <a:solidFill>
                  <a:prstClr val="black"/>
                </a:solidFill>
                <a:latin typeface="Segoe Condensed" panose="020B0606040200020203" pitchFamily="34" charset="0"/>
              </a:rPr>
              <a:t>2350</a:t>
            </a:r>
            <a:r>
              <a:rPr lang="en-US" sz="2400" dirty="0">
                <a:solidFill>
                  <a:prstClr val="black"/>
                </a:solidFill>
                <a:latin typeface="Segoe Condensed" panose="020B0606040200020203" pitchFamily="34" charset="0"/>
              </a:rPr>
              <a:t> alerts from </a:t>
            </a:r>
            <a:r>
              <a:rPr lang="en-US" sz="2400" b="1" dirty="0">
                <a:solidFill>
                  <a:prstClr val="black"/>
                </a:solidFill>
                <a:latin typeface="Segoe Condensed" panose="020B0606040200020203" pitchFamily="34" charset="0"/>
              </a:rPr>
              <a:t>40</a:t>
            </a:r>
            <a:r>
              <a:rPr lang="en-US" sz="2400" dirty="0">
                <a:solidFill>
                  <a:prstClr val="black"/>
                </a:solidFill>
                <a:latin typeface="Segoe Condensed" panose="020B0606040200020203" pitchFamily="34" charset="0"/>
              </a:rPr>
              <a:t> countries reported &amp; investigated</a:t>
            </a:r>
          </a:p>
          <a:p>
            <a:pPr marL="742950" lvl="1" indent="-285750">
              <a:buFont typeface="Segoe Condensed" panose="020B0606040200020203" pitchFamily="34" charset="0"/>
              <a:buChar char="‐"/>
              <a:defRPr/>
            </a:pPr>
            <a:r>
              <a:rPr lang="en-US" dirty="0">
                <a:solidFill>
                  <a:prstClr val="black"/>
                </a:solidFill>
                <a:latin typeface="Segoe Condensed" panose="020B0606040200020203" pitchFamily="34" charset="0"/>
              </a:rPr>
              <a:t>EVD systematically ruled out in all except for:</a:t>
            </a:r>
          </a:p>
          <a:p>
            <a:pPr marL="742950" lvl="1" indent="-285750">
              <a:buFont typeface="Segoe Condensed" panose="020B0606040200020203" pitchFamily="34" charset="0"/>
              <a:buChar char="‐"/>
              <a:defRPr/>
            </a:pPr>
            <a:r>
              <a:rPr lang="en-US" dirty="0">
                <a:solidFill>
                  <a:prstClr val="black"/>
                </a:solidFill>
                <a:latin typeface="Segoe Condensed" panose="020B0606040200020203" pitchFamily="34" charset="0"/>
              </a:rPr>
              <a:t>5 initial cases in Kasese, Uganda and 4 initial cases in Sud-Kivu , DR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2C85AC9A-5820-464C-A9F9-99A644BCC9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368" y="1143000"/>
            <a:ext cx="4078577" cy="4883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3573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Custom 15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7F7F7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Ebola DRC Epi data pack for 20181024.pptx" id="{2A3BAF0F-2BAE-450F-B6CB-A5696C872F8D}" vid="{76720631-9E58-44E3-9FA4-E7B6B3AD6EC7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773E3B195DDEC4DA3286754E5D2D861" ma:contentTypeVersion="13" ma:contentTypeDescription="Create a new document." ma:contentTypeScope="" ma:versionID="de7ec6e694bc77e549c10a4736f39baa">
  <xsd:schema xmlns:xsd="http://www.w3.org/2001/XMLSchema" xmlns:xs="http://www.w3.org/2001/XMLSchema" xmlns:p="http://schemas.microsoft.com/office/2006/metadata/properties" xmlns:ns3="f2f6d5af-f638-4f62-aa1e-f841ead3cdd3" xmlns:ns4="b4570ebe-0c37-4beb-883b-16e07b099dac" targetNamespace="http://schemas.microsoft.com/office/2006/metadata/properties" ma:root="true" ma:fieldsID="12ac21de7897d292c4cf1935581f1bb0" ns3:_="" ns4:_="">
    <xsd:import namespace="f2f6d5af-f638-4f62-aa1e-f841ead3cdd3"/>
    <xsd:import namespace="b4570ebe-0c37-4beb-883b-16e07b099da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f6d5af-f638-4f62-aa1e-f841ead3cdd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570ebe-0c37-4beb-883b-16e07b099dac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97140A7-F816-416F-99C2-752E7229F26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2f6d5af-f638-4f62-aa1e-f841ead3cdd3"/>
    <ds:schemaRef ds:uri="b4570ebe-0c37-4beb-883b-16e07b099da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FF99612-6C01-451F-9658-F5D8098BDC6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1C67EFA-E967-4D15-A0D7-9DCE17AD53D5}">
  <ds:schemaRefs>
    <ds:schemaRef ds:uri="http://purl.org/dc/elements/1.1/"/>
    <ds:schemaRef ds:uri="b4570ebe-0c37-4beb-883b-16e07b099dac"/>
    <ds:schemaRef ds:uri="f2f6d5af-f638-4f62-aa1e-f841ead3cdd3"/>
    <ds:schemaRef ds:uri="http://purl.org/dc/terms/"/>
    <ds:schemaRef ds:uri="http://schemas.microsoft.com/office/2006/metadata/properties"/>
    <ds:schemaRef ds:uri="http://www.w3.org/XML/1998/namespace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Ebola DRC Epi data pack for 201808XX</Template>
  <TotalTime>17690</TotalTime>
  <Words>69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Alerts from other provinces and neighbouring countries (data from 1 Aug 2018 – 25 Nov 2019)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pi data pack: EVD, Kivu &amp; Ituri provinces, DRC</dc:title>
  <dc:creator>CROWE, Madeleine Frances</dc:creator>
  <cp:lastModifiedBy>Olushayo Oluseun OLU</cp:lastModifiedBy>
  <cp:revision>1434</cp:revision>
  <cp:lastPrinted>2019-11-26T07:56:00Z</cp:lastPrinted>
  <dcterms:created xsi:type="dcterms:W3CDTF">2018-11-01T08:49:21Z</dcterms:created>
  <dcterms:modified xsi:type="dcterms:W3CDTF">2020-11-06T06:13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773E3B195DDEC4DA3286754E5D2D861</vt:lpwstr>
  </property>
</Properties>
</file>